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90" y="7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735607-BD00-4039-AEAB-E0BA4085AE16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695230-9C8E-402B-91E3-031C9CCA6C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988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9CE250-B0BE-4A08-983A-F8175133776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337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532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419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792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027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35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646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657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794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100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40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146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5AE784-DAA8-4535-BAFF-A229742395EA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CE5D0-72B6-40C2-BE42-E3A3E5800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168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11" Type="http://schemas.openxmlformats.org/officeDocument/2006/relationships/image" Target="../media/image17.tiff"/><Relationship Id="rId5" Type="http://schemas.openxmlformats.org/officeDocument/2006/relationships/image" Target="../media/image11.tiff"/><Relationship Id="rId10" Type="http://schemas.openxmlformats.org/officeDocument/2006/relationships/image" Target="../media/image16.tiff"/><Relationship Id="rId4" Type="http://schemas.openxmlformats.org/officeDocument/2006/relationships/image" Target="../media/image10.tiff"/><Relationship Id="rId9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9000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551115" y="244912"/>
            <a:ext cx="9811516" cy="7132762"/>
            <a:chOff x="551115" y="244912"/>
            <a:chExt cx="9811516" cy="7132762"/>
          </a:xfrm>
        </p:grpSpPr>
        <p:grpSp>
          <p:nvGrpSpPr>
            <p:cNvPr id="16" name="Group 15"/>
            <p:cNvGrpSpPr/>
            <p:nvPr/>
          </p:nvGrpSpPr>
          <p:grpSpPr>
            <a:xfrm>
              <a:off x="565011" y="5731754"/>
              <a:ext cx="2194560" cy="1645920"/>
              <a:chOff x="547593" y="5879793"/>
              <a:chExt cx="2194560" cy="1645920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xmlns="" id="{A8716C25-8CBE-4373-A389-71DCD773B9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7593" y="5879793"/>
                <a:ext cx="2194560" cy="16459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563891" y="5879793"/>
                <a:ext cx="423321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>
                    <a:latin typeface="Arial" charset="0"/>
                    <a:ea typeface="Arial" charset="0"/>
                    <a:cs typeface="Arial" charset="0"/>
                  </a:rPr>
                  <a:t>F.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274732" y="5887175"/>
                <a:ext cx="824456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Box #5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211969" y="5731754"/>
              <a:ext cx="2194560" cy="1645920"/>
              <a:chOff x="3229387" y="5879793"/>
              <a:chExt cx="2194560" cy="1645920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xmlns="" id="{5C8AEE80-3624-432C-B1F5-F72C65A86C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29387" y="5879793"/>
                <a:ext cx="2194560" cy="16459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56" name="TextBox 55"/>
              <p:cNvSpPr txBox="1"/>
              <p:nvPr/>
            </p:nvSpPr>
            <p:spPr>
              <a:xfrm>
                <a:off x="3241845" y="5879793"/>
                <a:ext cx="508473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>
                    <a:latin typeface="Arial" charset="0"/>
                    <a:ea typeface="Arial" charset="0"/>
                    <a:cs typeface="Arial" charset="0"/>
                  </a:rPr>
                  <a:t>G.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3915391" y="5887175"/>
                <a:ext cx="824456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Box #6</a:t>
                </a: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5860749" y="5731754"/>
              <a:ext cx="2194560" cy="1645920"/>
              <a:chOff x="5904294" y="5879793"/>
              <a:chExt cx="2194560" cy="1645920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xmlns="" id="{0DABEB0D-F92A-4A26-AC6C-1B1DB9A4BC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04294" y="5879793"/>
                <a:ext cx="2194560" cy="16459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61" name="TextBox 60"/>
              <p:cNvSpPr txBox="1"/>
              <p:nvPr/>
            </p:nvSpPr>
            <p:spPr>
              <a:xfrm>
                <a:off x="5918872" y="5879793"/>
                <a:ext cx="492443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2400" b="1">
                    <a:latin typeface="Arial" charset="0"/>
                    <a:ea typeface="Arial" charset="0"/>
                    <a:cs typeface="Arial" charset="0"/>
                  </a:rPr>
                  <a:t>H.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6621841" y="5887175"/>
                <a:ext cx="824456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Box #7</a:t>
                </a: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8168071" y="256348"/>
              <a:ext cx="2194560" cy="1645920"/>
              <a:chOff x="8612215" y="12512"/>
              <a:chExt cx="2194560" cy="1645920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D58B931B-49BC-479A-9958-403DF2CEBD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12215" y="12512"/>
                <a:ext cx="2194560" cy="16459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55" name="TextBox 54"/>
              <p:cNvSpPr txBox="1"/>
              <p:nvPr/>
            </p:nvSpPr>
            <p:spPr>
              <a:xfrm>
                <a:off x="8633659" y="19158"/>
                <a:ext cx="492443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>
                    <a:latin typeface="Arial" charset="0"/>
                    <a:ea typeface="Arial" charset="0"/>
                    <a:cs typeface="Arial" charset="0"/>
                  </a:rPr>
                  <a:t>B.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9385814" y="12512"/>
                <a:ext cx="824456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/>
                  <a:t>Box #1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8168071" y="5731754"/>
              <a:ext cx="2194560" cy="1645920"/>
              <a:chOff x="8612215" y="5879793"/>
              <a:chExt cx="2194560" cy="1645920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xmlns="" id="{67BF8131-7E4E-4B61-91F4-BC0C1A2DD9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12215" y="5879793"/>
                <a:ext cx="2194560" cy="16459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58" name="TextBox 57"/>
              <p:cNvSpPr txBox="1"/>
              <p:nvPr/>
            </p:nvSpPr>
            <p:spPr>
              <a:xfrm>
                <a:off x="8633659" y="5879793"/>
                <a:ext cx="474810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>
                    <a:latin typeface="Arial" charset="0"/>
                    <a:ea typeface="Arial" charset="0"/>
                    <a:cs typeface="Arial" charset="0"/>
                  </a:rPr>
                  <a:t>E.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9385814" y="5887175"/>
                <a:ext cx="824456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/>
                  <a:t>Box #4</a:t>
                </a: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8168071" y="3918579"/>
              <a:ext cx="2194560" cy="1645920"/>
              <a:chOff x="8612215" y="3927286"/>
              <a:chExt cx="2194560" cy="1645920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xmlns="" id="{19B107EA-061C-4BBE-83B9-F4627C258C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12215" y="3927286"/>
                <a:ext cx="2194560" cy="16459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59" name="TextBox 58"/>
              <p:cNvSpPr txBox="1"/>
              <p:nvPr/>
            </p:nvSpPr>
            <p:spPr>
              <a:xfrm>
                <a:off x="8633659" y="3943578"/>
                <a:ext cx="492443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>
                    <a:latin typeface="Arial" charset="0"/>
                    <a:ea typeface="Arial" charset="0"/>
                    <a:cs typeface="Arial" charset="0"/>
                  </a:rPr>
                  <a:t>D.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9385814" y="3941979"/>
                <a:ext cx="824456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/>
                  <a:t>Box #3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8168071" y="2082076"/>
              <a:ext cx="2194560" cy="1645920"/>
              <a:chOff x="8612215" y="1994993"/>
              <a:chExt cx="2194560" cy="164592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xmlns="" id="{6AB672D9-C953-4125-8D7E-51984A54B6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12215" y="1994993"/>
                <a:ext cx="2194560" cy="16459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60" name="TextBox 59"/>
              <p:cNvSpPr txBox="1"/>
              <p:nvPr/>
            </p:nvSpPr>
            <p:spPr>
              <a:xfrm>
                <a:off x="8633659" y="2006874"/>
                <a:ext cx="492443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>
                    <a:latin typeface="Arial" charset="0"/>
                    <a:ea typeface="Arial" charset="0"/>
                    <a:cs typeface="Arial" charset="0"/>
                  </a:rPr>
                  <a:t>C.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9385814" y="1998061"/>
                <a:ext cx="824456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/>
                  <a:t>Box #2</a:t>
                </a: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551115" y="244912"/>
              <a:ext cx="7529907" cy="5455293"/>
              <a:chOff x="315988" y="-120850"/>
              <a:chExt cx="7529907" cy="5455293"/>
            </a:xfrm>
          </p:grpSpPr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xmlns="" id="{12DDE318-F025-4A6A-A118-1DA5D34777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5988" y="-118345"/>
                <a:ext cx="7529907" cy="5452788"/>
              </a:xfrm>
              <a:prstGeom prst="rect">
                <a:avLst/>
              </a:prstGeom>
            </p:spPr>
          </p:pic>
          <p:sp>
            <p:nvSpPr>
              <p:cNvPr id="53" name="TextBox 52"/>
              <p:cNvSpPr txBox="1"/>
              <p:nvPr/>
            </p:nvSpPr>
            <p:spPr>
              <a:xfrm>
                <a:off x="328846" y="-120850"/>
                <a:ext cx="49244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A.</a:t>
                </a:r>
              </a:p>
            </p:txBody>
          </p: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xmlns="" id="{76AC6C65-4BFF-4E96-9402-609DB3A45D9E}"/>
                  </a:ext>
                </a:extLst>
              </p:cNvPr>
              <p:cNvGrpSpPr/>
              <p:nvPr/>
            </p:nvGrpSpPr>
            <p:grpSpPr>
              <a:xfrm>
                <a:off x="1198793" y="-72539"/>
                <a:ext cx="6647102" cy="5367258"/>
                <a:chOff x="867578" y="410312"/>
                <a:chExt cx="6384367" cy="5177401"/>
              </a:xfrm>
            </p:grpSpPr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xmlns="" id="{C72E64AE-F63D-4F70-8033-7D57E184A1A8}"/>
                    </a:ext>
                  </a:extLst>
                </p:cNvPr>
                <p:cNvSpPr/>
                <p:nvPr/>
              </p:nvSpPr>
              <p:spPr>
                <a:xfrm>
                  <a:off x="4196561" y="1183222"/>
                  <a:ext cx="459636" cy="407124"/>
                </a:xfrm>
                <a:prstGeom prst="rect">
                  <a:avLst/>
                </a:prstGeom>
                <a:solidFill>
                  <a:schemeClr val="tx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/>
                    <a:t>1</a:t>
                  </a:r>
                </a:p>
              </p:txBody>
            </p:sp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xmlns="" id="{394BE8F8-F221-4D38-BBDD-8724E70C094B}"/>
                    </a:ext>
                  </a:extLst>
                </p:cNvPr>
                <p:cNvSpPr/>
                <p:nvPr/>
              </p:nvSpPr>
              <p:spPr>
                <a:xfrm>
                  <a:off x="2065934" y="822824"/>
                  <a:ext cx="459636" cy="407124"/>
                </a:xfrm>
                <a:prstGeom prst="rect">
                  <a:avLst/>
                </a:prstGeom>
                <a:solidFill>
                  <a:schemeClr val="tx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/>
                    <a:t>2</a:t>
                  </a:r>
                </a:p>
              </p:txBody>
            </p:sp>
            <p:sp>
              <p:nvSpPr>
                <p:cNvPr id="40" name="Rectangle 39">
                  <a:extLst>
                    <a:ext uri="{FF2B5EF4-FFF2-40B4-BE49-F238E27FC236}">
                      <a16:creationId xmlns:a16="http://schemas.microsoft.com/office/drawing/2014/main" xmlns="" id="{6FB8154C-CD87-42DD-B84D-6B67F5E0CAF9}"/>
                    </a:ext>
                  </a:extLst>
                </p:cNvPr>
                <p:cNvSpPr/>
                <p:nvPr/>
              </p:nvSpPr>
              <p:spPr>
                <a:xfrm>
                  <a:off x="2002399" y="2683276"/>
                  <a:ext cx="459636" cy="407125"/>
                </a:xfrm>
                <a:prstGeom prst="rect">
                  <a:avLst/>
                </a:prstGeom>
                <a:solidFill>
                  <a:schemeClr val="tx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/>
                    <a:t>3</a:t>
                  </a:r>
                </a:p>
              </p:txBody>
            </p:sp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xmlns="" id="{6CA85A71-931C-487D-B4BD-29C0D25034AD}"/>
                    </a:ext>
                  </a:extLst>
                </p:cNvPr>
                <p:cNvSpPr/>
                <p:nvPr/>
              </p:nvSpPr>
              <p:spPr>
                <a:xfrm>
                  <a:off x="4953922" y="3227534"/>
                  <a:ext cx="459636" cy="407124"/>
                </a:xfrm>
                <a:prstGeom prst="rect">
                  <a:avLst/>
                </a:prstGeom>
                <a:solidFill>
                  <a:schemeClr val="tx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/>
                    <a:t>4</a:t>
                  </a:r>
                </a:p>
              </p:txBody>
            </p:sp>
            <p:sp>
              <p:nvSpPr>
                <p:cNvPr id="42" name="Rectangle 41">
                  <a:extLst>
                    <a:ext uri="{FF2B5EF4-FFF2-40B4-BE49-F238E27FC236}">
                      <a16:creationId xmlns:a16="http://schemas.microsoft.com/office/drawing/2014/main" xmlns="" id="{C5AED8CF-FF02-42EB-A5AC-294697A4D7F7}"/>
                    </a:ext>
                  </a:extLst>
                </p:cNvPr>
                <p:cNvSpPr/>
                <p:nvPr/>
              </p:nvSpPr>
              <p:spPr>
                <a:xfrm>
                  <a:off x="6792309" y="3017221"/>
                  <a:ext cx="459636" cy="407124"/>
                </a:xfrm>
                <a:prstGeom prst="rect">
                  <a:avLst/>
                </a:prstGeom>
                <a:solidFill>
                  <a:schemeClr val="tx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/>
                    <a:t>5</a:t>
                  </a:r>
                </a:p>
              </p:txBody>
            </p:sp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xmlns="" id="{6315C078-DF73-4297-AAEA-D6858A156E6F}"/>
                    </a:ext>
                  </a:extLst>
                </p:cNvPr>
                <p:cNvSpPr/>
                <p:nvPr/>
              </p:nvSpPr>
              <p:spPr>
                <a:xfrm>
                  <a:off x="6004141" y="4545565"/>
                  <a:ext cx="459636" cy="441219"/>
                </a:xfrm>
                <a:prstGeom prst="rect">
                  <a:avLst/>
                </a:prstGeom>
                <a:solidFill>
                  <a:schemeClr val="tx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/>
                    <a:t>7</a:t>
                  </a:r>
                </a:p>
              </p:txBody>
            </p:sp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xmlns="" id="{29AF559F-100A-4CC2-8CDB-279FAE8B9B13}"/>
                    </a:ext>
                  </a:extLst>
                </p:cNvPr>
                <p:cNvSpPr/>
                <p:nvPr/>
              </p:nvSpPr>
              <p:spPr>
                <a:xfrm>
                  <a:off x="1519543" y="4087538"/>
                  <a:ext cx="459636" cy="407125"/>
                </a:xfrm>
                <a:prstGeom prst="rect">
                  <a:avLst/>
                </a:prstGeom>
                <a:solidFill>
                  <a:schemeClr val="tx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/>
                    <a:t>6</a:t>
                  </a:r>
                </a:p>
              </p:txBody>
            </p:sp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xmlns="" id="{7A4C94C4-BC37-4A0D-9478-188FC9B52370}"/>
                    </a:ext>
                  </a:extLst>
                </p:cNvPr>
                <p:cNvSpPr/>
                <p:nvPr/>
              </p:nvSpPr>
              <p:spPr>
                <a:xfrm>
                  <a:off x="6140713" y="410312"/>
                  <a:ext cx="844353" cy="902932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600">
                      <a:solidFill>
                        <a:srgbClr val="FF0000"/>
                      </a:solidFill>
                    </a:rPr>
                    <a:t>A*</a:t>
                  </a:r>
                </a:p>
              </p:txBody>
            </p:sp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xmlns="" id="{B9DCC378-C82D-452A-90A6-F9D46080800A}"/>
                    </a:ext>
                  </a:extLst>
                </p:cNvPr>
                <p:cNvSpPr/>
                <p:nvPr/>
              </p:nvSpPr>
              <p:spPr>
                <a:xfrm>
                  <a:off x="867578" y="3963830"/>
                  <a:ext cx="672029" cy="652749"/>
                </a:xfrm>
                <a:prstGeom prst="rect">
                  <a:avLst/>
                </a:prstGeom>
                <a:noFill/>
                <a:ln w="190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xmlns="" id="{3F3620A8-B2A5-403C-A908-3E918AD06C1B}"/>
                    </a:ext>
                  </a:extLst>
                </p:cNvPr>
                <p:cNvSpPr/>
                <p:nvPr/>
              </p:nvSpPr>
              <p:spPr>
                <a:xfrm>
                  <a:off x="1431307" y="2049622"/>
                  <a:ext cx="672030" cy="652749"/>
                </a:xfrm>
                <a:prstGeom prst="rect">
                  <a:avLst/>
                </a:prstGeom>
                <a:noFill/>
                <a:ln w="190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xmlns="" id="{745AE02A-20A5-4A75-BFB4-068A727CBD52}"/>
                    </a:ext>
                  </a:extLst>
                </p:cNvPr>
                <p:cNvSpPr/>
                <p:nvPr/>
              </p:nvSpPr>
              <p:spPr>
                <a:xfrm>
                  <a:off x="5373702" y="2724217"/>
                  <a:ext cx="672029" cy="652749"/>
                </a:xfrm>
                <a:prstGeom prst="rect">
                  <a:avLst/>
                </a:prstGeom>
                <a:noFill/>
                <a:ln w="190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xmlns="" id="{0D13FD95-F05D-4993-910E-7D03330DBA05}"/>
                    </a:ext>
                  </a:extLst>
                </p:cNvPr>
                <p:cNvSpPr/>
                <p:nvPr/>
              </p:nvSpPr>
              <p:spPr>
                <a:xfrm>
                  <a:off x="5496820" y="4934964"/>
                  <a:ext cx="672029" cy="652749"/>
                </a:xfrm>
                <a:prstGeom prst="rect">
                  <a:avLst/>
                </a:prstGeom>
                <a:noFill/>
                <a:ln w="190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0" name="Rectangle 49">
                  <a:extLst>
                    <a:ext uri="{FF2B5EF4-FFF2-40B4-BE49-F238E27FC236}">
                      <a16:creationId xmlns:a16="http://schemas.microsoft.com/office/drawing/2014/main" xmlns="" id="{8CDB2CD4-FE2D-4F27-9BAA-8BCF4CA2E4BA}"/>
                    </a:ext>
                  </a:extLst>
                </p:cNvPr>
                <p:cNvSpPr/>
                <p:nvPr/>
              </p:nvSpPr>
              <p:spPr>
                <a:xfrm>
                  <a:off x="6541787" y="2331155"/>
                  <a:ext cx="672029" cy="652749"/>
                </a:xfrm>
                <a:prstGeom prst="rect">
                  <a:avLst/>
                </a:prstGeom>
                <a:noFill/>
                <a:ln w="190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xmlns="" id="{5175055E-6C55-45D2-B01D-0A349211229F}"/>
                    </a:ext>
                  </a:extLst>
                </p:cNvPr>
                <p:cNvSpPr/>
                <p:nvPr/>
              </p:nvSpPr>
              <p:spPr>
                <a:xfrm>
                  <a:off x="4579169" y="653985"/>
                  <a:ext cx="672029" cy="652749"/>
                </a:xfrm>
                <a:prstGeom prst="rect">
                  <a:avLst/>
                </a:prstGeom>
                <a:noFill/>
                <a:ln w="190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xmlns="" id="{92A1770F-AACF-4AD2-95FC-B9568CEB8C05}"/>
                    </a:ext>
                  </a:extLst>
                </p:cNvPr>
                <p:cNvSpPr/>
                <p:nvPr/>
              </p:nvSpPr>
              <p:spPr>
                <a:xfrm>
                  <a:off x="2499651" y="425220"/>
                  <a:ext cx="672029" cy="652749"/>
                </a:xfrm>
                <a:prstGeom prst="rect">
                  <a:avLst/>
                </a:prstGeom>
                <a:noFill/>
                <a:ln w="190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6349463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52327" y="140247"/>
            <a:ext cx="15856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>
                <a:latin typeface="Arial" charset="0"/>
                <a:ea typeface="Arial" charset="0"/>
                <a:cs typeface="Arial" charset="0"/>
              </a:rPr>
              <a:t>Figure Supplemental 2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841770" y="137160"/>
            <a:ext cx="8980285" cy="6720840"/>
            <a:chOff x="1841770" y="137160"/>
            <a:chExt cx="8980285" cy="672084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017C6F13-98FE-4E73-AC88-BC8E3826DB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1770" y="239522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4AC3F095-EAE5-418C-9493-0D53D6318DC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1770" y="13716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DE48E585-DC8E-4104-BE8A-3EC30C450C3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6141" y="13716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53F4A2DF-6A6C-4E32-8F18-74A88BBAE19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95975" y="13716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313970C3-217F-4775-9528-E8589CC6176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1770" y="466344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22D7E154-FDBA-49B0-8118-9544F89FA83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6141" y="239522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BF378F06-E9C6-4EA0-8954-7243350E5EC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95975" y="239522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C2DA9F55-31CA-4F11-BCB5-03DA97372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95975" y="466344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C6D2D209-4998-4508-B790-1E8A24EC79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6141" y="4663440"/>
              <a:ext cx="2926080" cy="219456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8927383" y="148315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/>
                <a:t>Box #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927383" y="4690573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/>
                <a:t>Box #9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927383" y="2433852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/>
                <a:t>Box #6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120683" y="148315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/>
                <a:t>Box #2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120683" y="4690573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/>
                <a:t>Box #8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120683" y="2433852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/>
                <a:t>Box #5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983783" y="148315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ox #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983783" y="4690573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ox #7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983783" y="2433852"/>
              <a:ext cx="8244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ox #4</a:t>
              </a: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4882396" y="2412692"/>
              <a:ext cx="47481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latin typeface="Arial" charset="0"/>
                  <a:ea typeface="Arial" charset="0"/>
                  <a:cs typeface="Arial" charset="0"/>
                </a:rPr>
                <a:t>E.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882396" y="140248"/>
              <a:ext cx="492443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charset="0"/>
                  <a:ea typeface="Arial" charset="0"/>
                  <a:cs typeface="Arial" charset="0"/>
                </a:rPr>
                <a:t>B.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910322" y="140248"/>
              <a:ext cx="492443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charset="0"/>
                  <a:ea typeface="Arial" charset="0"/>
                  <a:cs typeface="Arial" charset="0"/>
                </a:rPr>
                <a:t>C.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882396" y="4682506"/>
              <a:ext cx="492443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latin typeface="Arial" charset="0"/>
                  <a:ea typeface="Arial" charset="0"/>
                  <a:cs typeface="Arial" charset="0"/>
                </a:rPr>
                <a:t>H.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910322" y="4682506"/>
              <a:ext cx="354584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latin typeface="Arial" charset="0"/>
                  <a:ea typeface="Arial" charset="0"/>
                  <a:cs typeface="Arial" charset="0"/>
                </a:rPr>
                <a:t>I.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910322" y="2412692"/>
              <a:ext cx="423321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latin typeface="Arial" charset="0"/>
                  <a:ea typeface="Arial" charset="0"/>
                  <a:cs typeface="Arial" charset="0"/>
                </a:rPr>
                <a:t>F.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854470" y="140248"/>
              <a:ext cx="492443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charset="0"/>
                  <a:ea typeface="Arial" charset="0"/>
                  <a:cs typeface="Arial" charset="0"/>
                </a:rPr>
                <a:t>A.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854470" y="2412692"/>
              <a:ext cx="492443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charset="0"/>
                  <a:ea typeface="Arial" charset="0"/>
                  <a:cs typeface="Arial" charset="0"/>
                </a:rPr>
                <a:t>D.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854470" y="4682506"/>
              <a:ext cx="508473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charset="0"/>
                  <a:ea typeface="Arial" charset="0"/>
                  <a:cs typeface="Arial" charset="0"/>
                </a:rPr>
                <a:t>G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942425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101" y="161380"/>
            <a:ext cx="3230927" cy="259219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56" r="10420"/>
          <a:stretch/>
        </p:blipFill>
        <p:spPr>
          <a:xfrm>
            <a:off x="4189392" y="0"/>
            <a:ext cx="4391025" cy="44301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9551" y="342355"/>
            <a:ext cx="4302401" cy="3451926"/>
          </a:xfrm>
          <a:prstGeom prst="rect">
            <a:avLst/>
          </a:prstGeom>
          <a:ln>
            <a:solidFill>
              <a:srgbClr val="FF0000"/>
            </a:solidFill>
            <a:prstDash val="dash"/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283"/>
          <a:stretch/>
        </p:blipFill>
        <p:spPr>
          <a:xfrm>
            <a:off x="33007" y="3124200"/>
            <a:ext cx="4029727" cy="37719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2686050" y="638175"/>
            <a:ext cx="863978" cy="81930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1160110" y="3806391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1851626" y="6350102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V="1">
            <a:off x="1192747" y="4172190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V="1">
            <a:off x="1632437" y="5585074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V="1">
            <a:off x="1311650" y="4604096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V="1">
            <a:off x="1681236" y="5999644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V="1">
            <a:off x="4909443" y="2919968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V="1">
            <a:off x="5067619" y="2554035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6404562" y="879822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V="1">
            <a:off x="6562738" y="513889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V="1">
            <a:off x="9810744" y="2062718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V="1">
            <a:off x="9968920" y="1696785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V="1">
            <a:off x="8990074" y="2552937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V="1">
            <a:off x="9148250" y="2187004"/>
            <a:ext cx="258176" cy="124286"/>
          </a:xfrm>
          <a:prstGeom prst="straightConnector1">
            <a:avLst/>
          </a:prstGeom>
          <a:ln w="57150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93708" y="6667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/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913065" y="468273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/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351350" y="6667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/>
              <a:t>B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11342" y="3201948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/>
              <a:t>D</a:t>
            </a:r>
          </a:p>
        </p:txBody>
      </p:sp>
      <p:sp>
        <p:nvSpPr>
          <p:cNvPr id="28" name="Rectangle 27"/>
          <p:cNvSpPr/>
          <p:nvPr/>
        </p:nvSpPr>
        <p:spPr>
          <a:xfrm>
            <a:off x="4189392" y="2062718"/>
            <a:ext cx="1842242" cy="151868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6031634" y="342355"/>
            <a:ext cx="1697917" cy="1720363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6031634" y="3581400"/>
            <a:ext cx="1697917" cy="22499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921090" y="4579228"/>
            <a:ext cx="17416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>
                <a:latin typeface="Arial" charset="0"/>
                <a:ea typeface="Arial" charset="0"/>
                <a:cs typeface="Arial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375287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03</Words>
  <Application>Microsoft Office PowerPoint</Application>
  <PresentationFormat>Widescreen</PresentationFormat>
  <Paragraphs>49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ry Figures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spswfh</dc:creator>
  <cp:lastModifiedBy>spswfh</cp:lastModifiedBy>
  <cp:revision>1</cp:revision>
  <dcterms:created xsi:type="dcterms:W3CDTF">2021-04-20T07:12:02Z</dcterms:created>
  <dcterms:modified xsi:type="dcterms:W3CDTF">2021-04-20T07:18:40Z</dcterms:modified>
</cp:coreProperties>
</file>